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1" autoAdjust="0"/>
    <p:restoredTop sz="94660"/>
  </p:normalViewPr>
  <p:slideViewPr>
    <p:cSldViewPr snapToGrid="0">
      <p:cViewPr varScale="1">
        <p:scale>
          <a:sx n="210" d="100"/>
          <a:sy n="210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78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245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126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573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696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064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936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054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80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41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575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F4AACB-FE88-4537-B01B-AA32120177A1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AA770-66F1-4E03-8FAB-23D71153A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86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476943" y="811617"/>
            <a:ext cx="2476500" cy="2305050"/>
            <a:chOff x="476943" y="504046"/>
            <a:chExt cx="2476500" cy="2305050"/>
          </a:xfrm>
        </p:grpSpPr>
        <p:pic>
          <p:nvPicPr>
            <p:cNvPr id="4" name="Picture 3" descr="C:\Users\lxp236\Desktop\TJU-PostDoc\WesternBlot\Exp30_LP30_20Jan2021\lp 30a arid1b 1sec 2021.01.21_12.32.05_Ch\lp 30a arid1b 1sec 2021.01.21_12.32.05_Ch+Marker.jpg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66" t="36512" r="7986" b="40000"/>
            <a:stretch/>
          </p:blipFill>
          <p:spPr bwMode="auto">
            <a:xfrm>
              <a:off x="476943" y="504046"/>
              <a:ext cx="2476500" cy="96202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5" name="Picture 4" descr="C:\Users\lxp236\Desktop\TJU-PostDoc\WesternBlot\Exp30_LP30_20Jan2021\lp 30 gapdh  1sec 2021.01.21_12.42.15_Ch\lp 30 gapdh  1sec 2021.01.21_12.42.15_Ch+Marker.jpg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68" t="29767" r="9625" b="37442"/>
            <a:stretch/>
          </p:blipFill>
          <p:spPr bwMode="auto">
            <a:xfrm>
              <a:off x="476943" y="1466071"/>
              <a:ext cx="2476500" cy="134302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7" name="TextBox 6"/>
          <p:cNvSpPr txBox="1"/>
          <p:nvPr/>
        </p:nvSpPr>
        <p:spPr>
          <a:xfrm>
            <a:off x="630383" y="309557"/>
            <a:ext cx="1946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 2c, ARID1B Time Cours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859579" y="1165671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ARID1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859579" y="1823711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GAPDH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2" b="73011"/>
          <a:stretch/>
        </p:blipFill>
        <p:spPr>
          <a:xfrm>
            <a:off x="4525234" y="769994"/>
            <a:ext cx="2912132" cy="109606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252" b="1826"/>
          <a:stretch/>
        </p:blipFill>
        <p:spPr>
          <a:xfrm flipH="1">
            <a:off x="4605213" y="1991689"/>
            <a:ext cx="2965156" cy="78120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7387489" y="1038713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ARID1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513409" y="2211295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GAPDH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497185" y="345067"/>
            <a:ext cx="1946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 6a, ARID1A Time Cours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086946" y="339394"/>
            <a:ext cx="1946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 6b, ARID1A CNC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390917" y="3742247"/>
            <a:ext cx="2645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 S1c, Chromatin Fraction of ARID1B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337" t="15636" b="55778"/>
          <a:stretch/>
        </p:blipFill>
        <p:spPr>
          <a:xfrm>
            <a:off x="9640299" y="4089801"/>
            <a:ext cx="1152945" cy="117209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664" t="44628" b="23745"/>
          <a:stretch/>
        </p:blipFill>
        <p:spPr>
          <a:xfrm>
            <a:off x="9640299" y="5261895"/>
            <a:ext cx="1152945" cy="1296785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0687704" y="4661193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ARID1B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0687704" y="5960245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HISTONE 3</a:t>
            </a:r>
          </a:p>
        </p:txBody>
      </p:sp>
      <p:pic>
        <p:nvPicPr>
          <p:cNvPr id="1026" name="Picture 2" descr="https://northcentralus1-mediap.svc.ms/transform/thumbnail?provider=spo&amp;inputFormat=jpg&amp;cs=fFNQTw&amp;docid=https%3A%2F%2Ftjuv-my.sharepoint.com%3A443%2F_api%2Fv2.0%2Fdrives%2Fb!UbuA9dGdKkSy5QROGAZWongtUuunt7RAqAXHwc-iLdEAmA4E0oGYQKmzX57EwInx%2Fitems%2F01ND4YZTHGTXDBNPCWBZD26CBEFF7T5SOK%3Fversion%3DPublished&amp;access_token=eyJ0eXAiOiJKV1QiLCJhbGciOiJub25lIn0.eyJhdWQiOiIwMDAwMDAwMy0wMDAwLTBmZjEtY2UwMC0wMDAwMDAwMDAwMDAvdGp1di1teS5zaGFyZXBvaW50LmNvbUA1NWE4OTkwNi1jNzEwLTQzNmItYmM0NC00YzU5MGNiNjdjNGEiLCJpc3MiOiIwMDAwMDAwMy0wMDAwLTBmZjEtY2UwMC0wMDAwMDAwMDAwMDAiLCJuYmYiOiIxNjE3MDQwODAwIiwiZXhwIjoiMTYxNzA2MjQwMCIsImVuZHBvaW50dXJsIjoibGNkNEdacmIvbzl0MGhFb3ZwcXlPVkxlTTJZSFF5WjBEVy8xbS9jU2FRdz0iLCJlbmRwb2ludHVybExlbmd0aCI6IjExNCIsImlzbG9vcGJhY2siOiJUcnVlIiwidmVyIjoiaGFzaGVkcHJvb2Z0b2tlbiIsInNpdGVpZCI6IlpqVTRNR0ppTlRFdE9XUmtNUzAwTkRKaExXSXlaVFV0TURRMFpURTRNRFkxTm1FeSIsIm5hbWVpZCI6IjAjLmZ8bWVtYmVyc2hpcHxseHAyMzZAamVmZmVyc29uLmVkdSIsIm5paSI6Im1pY3Jvc29mdC5zaGFyZXBvaW50IiwiaXN1c2VyIjoidHJ1ZSIsImNhY2hla2V5IjoiMGguZnxtZW1iZXJzaGlwfDEwMDMyMDAwNzg3ZmMzNWZAbGl2ZS5jb20iLCJ0dCI6IjAiLCJ1c2VQZXJzaXN0ZW50Q29va2llIjoiMiJ9.eUtqZmd2ZUZQUzFPUGxTUDQxV015dHJDdVZRK1QvUzd0N0tNbGRJVUpZST0&amp;encodeFailures=1&amp;width=611&amp;height=840&amp;srcWidth=1024&amp;srcHeight=140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25" t="13025" r="57252" b="65804"/>
          <a:stretch/>
        </p:blipFill>
        <p:spPr bwMode="auto">
          <a:xfrm>
            <a:off x="9296119" y="754305"/>
            <a:ext cx="1065048" cy="9865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10308397" y="993649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ARID1A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85" t="57395" r="48421" b="19285"/>
          <a:stretch/>
        </p:blipFill>
        <p:spPr>
          <a:xfrm>
            <a:off x="9305664" y="1788487"/>
            <a:ext cx="1059915" cy="1030081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0322559" y="1980169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ACTIN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443748" y="3740949"/>
            <a:ext cx="2766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 S1c, Cytoplasmic Fraction of ARID1B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5" t="16043" r="60465" b="56182"/>
          <a:stretch/>
        </p:blipFill>
        <p:spPr>
          <a:xfrm>
            <a:off x="7088229" y="4155860"/>
            <a:ext cx="1138844" cy="1138844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8218914" y="4750062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ARID1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8166144" y="5524707"/>
            <a:ext cx="8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GAPDH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94063" y="1142652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25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9053144" y="992458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25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0374714" y="4489755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25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185213" y="1066109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25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254486" y="4588271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25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0530992" y="5985231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15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7185213" y="1328139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130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9055004" y="1181910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13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0385976" y="4697721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13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86271" y="1292705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130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0515934" y="5438215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35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7204609" y="2124503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35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87408" y="1956274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35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9180563" y="2071690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35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7252203" y="4766646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130</a:t>
            </a: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5" t="26573" r="61551" b="40379"/>
          <a:stretch/>
        </p:blipFill>
        <p:spPr>
          <a:xfrm>
            <a:off x="7088229" y="5285265"/>
            <a:ext cx="1138844" cy="1473333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7204609" y="5547791"/>
            <a:ext cx="365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35</a:t>
            </a:r>
          </a:p>
        </p:txBody>
      </p:sp>
    </p:spTree>
    <p:extLst>
      <p:ext uri="{BB962C8B-B14F-4D97-AF65-F5344CB8AC3E}">
        <p14:creationId xmlns:p14="http://schemas.microsoft.com/office/powerpoint/2010/main" val="2328250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8</TotalTime>
  <Words>58</Words>
  <Application>Microsoft Macintosh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omas Jefferson University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a Pagliaroli</dc:creator>
  <cp:lastModifiedBy>Marco Trizzino</cp:lastModifiedBy>
  <cp:revision>9</cp:revision>
  <dcterms:created xsi:type="dcterms:W3CDTF">2021-03-29T16:15:11Z</dcterms:created>
  <dcterms:modified xsi:type="dcterms:W3CDTF">2021-03-30T15:10:12Z</dcterms:modified>
</cp:coreProperties>
</file>